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224" y="-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38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199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387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950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019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518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705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46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12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826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73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8E30E-C657-447E-B69B-C8BE64A9079D}" type="datetimeFigureOut">
              <a:rPr lang="en-US" smtClean="0"/>
              <a:t>1/3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4CFC9-A5A5-42DA-827E-F022AAD842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333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/>
          <p:cNvSpPr/>
          <p:nvPr/>
        </p:nvSpPr>
        <p:spPr>
          <a:xfrm>
            <a:off x="476672" y="526485"/>
            <a:ext cx="5797424" cy="4924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Risk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as Summary.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s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view authors' judgements about each risk of bias item for each included study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uppo 3"/>
          <p:cNvGrpSpPr/>
          <p:nvPr/>
        </p:nvGrpSpPr>
        <p:grpSpPr>
          <a:xfrm>
            <a:off x="476672" y="1403648"/>
            <a:ext cx="3744416" cy="7402465"/>
            <a:chOff x="1085850" y="2162174"/>
            <a:chExt cx="4436790" cy="8410577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00" t="17057" r="34100" b="6688"/>
            <a:stretch/>
          </p:blipFill>
          <p:spPr bwMode="auto">
            <a:xfrm>
              <a:off x="1085850" y="2162174"/>
              <a:ext cx="4436790" cy="55781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00" t="52032" r="34100" b="9249"/>
            <a:stretch/>
          </p:blipFill>
          <p:spPr bwMode="auto">
            <a:xfrm>
              <a:off x="1085850" y="7740353"/>
              <a:ext cx="4436790" cy="2832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402928525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26</Words>
  <Application>Microsoft Office PowerPoint</Application>
  <PresentationFormat>Presentazione su schermo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ld90@hotmail.it</dc:creator>
  <cp:lastModifiedBy>gld90@hotmail.it</cp:lastModifiedBy>
  <cp:revision>3</cp:revision>
  <dcterms:created xsi:type="dcterms:W3CDTF">2018-12-28T12:25:08Z</dcterms:created>
  <dcterms:modified xsi:type="dcterms:W3CDTF">2019-01-03T09:58:55Z</dcterms:modified>
</cp:coreProperties>
</file>